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0" r:id="rId2"/>
  </p:sldIdLst>
  <p:sldSz cx="6264275" cy="842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9877"/>
    <a:srgbClr val="EEBC96"/>
    <a:srgbClr val="F4D4D4"/>
    <a:srgbClr val="F3D7D1"/>
    <a:srgbClr val="6087CE"/>
    <a:srgbClr val="4674C6"/>
    <a:srgbClr val="83ABD7"/>
    <a:srgbClr val="26457C"/>
    <a:srgbClr val="4472C4"/>
    <a:srgbClr val="9FB7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51" autoAdjust="0"/>
    <p:restoredTop sz="94198" autoAdjust="0"/>
  </p:normalViewPr>
  <p:slideViewPr>
    <p:cSldViewPr>
      <p:cViewPr varScale="1">
        <p:scale>
          <a:sx n="81" d="100"/>
          <a:sy n="81" d="100"/>
        </p:scale>
        <p:origin x="3360" y="84"/>
      </p:cViewPr>
      <p:guideLst>
        <p:guide orient="horz" pos="2653"/>
        <p:guide pos="19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5FF59-7695-48F5-AB78-39D11FDC9794}" type="datetimeFigureOut">
              <a:rPr lang="ko-KR" altLang="en-US" smtClean="0"/>
              <a:t>2025-08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6247F1-F2E7-41F9-89F3-984DCCE2D2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75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6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8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60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650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20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59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61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58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33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40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21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1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1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그룹 22">
            <a:extLst>
              <a:ext uri="{FF2B5EF4-FFF2-40B4-BE49-F238E27FC236}">
                <a16:creationId xmlns:a16="http://schemas.microsoft.com/office/drawing/2014/main" id="{C650B39D-613F-4345-AC5A-63214B25189B}"/>
              </a:ext>
            </a:extLst>
          </p:cNvPr>
          <p:cNvGrpSpPr/>
          <p:nvPr/>
        </p:nvGrpSpPr>
        <p:grpSpPr>
          <a:xfrm>
            <a:off x="323825" y="1439329"/>
            <a:ext cx="1235735" cy="960924"/>
            <a:chOff x="359829" y="1738545"/>
            <a:chExt cx="1235735" cy="960924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079E85AD-65B5-45B6-842B-F276848E1D0C}"/>
                </a:ext>
              </a:extLst>
            </p:cNvPr>
            <p:cNvGrpSpPr/>
            <p:nvPr/>
          </p:nvGrpSpPr>
          <p:grpSpPr>
            <a:xfrm>
              <a:off x="359829" y="1979469"/>
              <a:ext cx="1235735" cy="720000"/>
              <a:chOff x="586252" y="2401574"/>
              <a:chExt cx="1235735" cy="720000"/>
            </a:xfrm>
          </p:grpSpPr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EFAA8B07-BA5D-48D7-B819-AC94EB9601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35" t="11010" r="17893" b="20403"/>
              <a:stretch/>
            </p:blipFill>
            <p:spPr>
              <a:xfrm>
                <a:off x="586252" y="2401574"/>
                <a:ext cx="1235735" cy="720000"/>
              </a:xfrm>
              <a:prstGeom prst="rect">
                <a:avLst/>
              </a:prstGeom>
            </p:spPr>
          </p:pic>
          <p:sp>
            <p:nvSpPr>
              <p:cNvPr id="16" name="타원 15">
                <a:extLst>
                  <a:ext uri="{FF2B5EF4-FFF2-40B4-BE49-F238E27FC236}">
                    <a16:creationId xmlns:a16="http://schemas.microsoft.com/office/drawing/2014/main" id="{0CC48E5B-0012-41B0-8BC9-F3984C33B694}"/>
                  </a:ext>
                </a:extLst>
              </p:cNvPr>
              <p:cNvSpPr/>
              <p:nvPr/>
            </p:nvSpPr>
            <p:spPr>
              <a:xfrm rot="2821150">
                <a:off x="1122548" y="2397655"/>
                <a:ext cx="477688" cy="847835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429FF81A-F84C-4E05-BA3E-DB5FB102E485}"/>
                </a:ext>
              </a:extLst>
            </p:cNvPr>
            <p:cNvSpPr/>
            <p:nvPr/>
          </p:nvSpPr>
          <p:spPr>
            <a:xfrm>
              <a:off x="611857" y="1738545"/>
              <a:ext cx="6832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YB10-1B</a:t>
              </a:r>
              <a:endParaRPr lang="ko-KR" altLang="en-US" sz="800" i="1" dirty="0"/>
            </a:p>
          </p:txBody>
        </p: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EE11D4CD-4C91-488A-BBBA-428868E9669A}"/>
              </a:ext>
            </a:extLst>
          </p:cNvPr>
          <p:cNvGrpSpPr/>
          <p:nvPr/>
        </p:nvGrpSpPr>
        <p:grpSpPr>
          <a:xfrm>
            <a:off x="2054154" y="1439329"/>
            <a:ext cx="1694212" cy="924920"/>
            <a:chOff x="2304045" y="1738545"/>
            <a:chExt cx="1694212" cy="924920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D94941E0-A413-4D3F-9BAE-C7A0A9761F46}"/>
                </a:ext>
              </a:extLst>
            </p:cNvPr>
            <p:cNvGrpSpPr/>
            <p:nvPr/>
          </p:nvGrpSpPr>
          <p:grpSpPr>
            <a:xfrm>
              <a:off x="2304045" y="1943465"/>
              <a:ext cx="1694212" cy="720000"/>
              <a:chOff x="2365777" y="2388874"/>
              <a:chExt cx="1694212" cy="720000"/>
            </a:xfrm>
          </p:grpSpPr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CE2CE124-9F17-4334-BF22-32C5CE0C3A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62" t="18181" r="8729" b="16809"/>
              <a:stretch/>
            </p:blipFill>
            <p:spPr>
              <a:xfrm>
                <a:off x="2365777" y="2388874"/>
                <a:ext cx="1664702" cy="720000"/>
              </a:xfrm>
              <a:prstGeom prst="rect">
                <a:avLst/>
              </a:prstGeom>
            </p:spPr>
          </p:pic>
          <p:sp>
            <p:nvSpPr>
              <p:cNvPr id="14" name="타원 13">
                <a:extLst>
                  <a:ext uri="{FF2B5EF4-FFF2-40B4-BE49-F238E27FC236}">
                    <a16:creationId xmlns:a16="http://schemas.microsoft.com/office/drawing/2014/main" id="{F037A39E-2C36-4813-BE27-F7F2B2A4BF3A}"/>
                  </a:ext>
                </a:extLst>
              </p:cNvPr>
              <p:cNvSpPr/>
              <p:nvPr/>
            </p:nvSpPr>
            <p:spPr>
              <a:xfrm rot="2821150">
                <a:off x="3397228" y="2410853"/>
                <a:ext cx="477688" cy="847835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1AC7F05E-8CAE-4673-AD8F-AACF1943B9DA}"/>
                </a:ext>
              </a:extLst>
            </p:cNvPr>
            <p:cNvSpPr/>
            <p:nvPr/>
          </p:nvSpPr>
          <p:spPr>
            <a:xfrm>
              <a:off x="2804168" y="1738545"/>
              <a:ext cx="6880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YB10-1C</a:t>
              </a:r>
              <a:endParaRPr lang="ko-KR" altLang="en-US" sz="800" dirty="0"/>
            </a:p>
          </p:txBody>
        </p:sp>
      </p:grp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24664C5C-22D2-48EE-9CB8-D622E0E622C9}"/>
              </a:ext>
            </a:extLst>
          </p:cNvPr>
          <p:cNvSpPr/>
          <p:nvPr/>
        </p:nvSpPr>
        <p:spPr>
          <a:xfrm>
            <a:off x="251818" y="2684219"/>
            <a:ext cx="5760640" cy="400110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r>
              <a:rPr lang="en-US" altLang="ko-KR" sz="10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2.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protein structures of MYB10-1B, MYB10-1C, and MYB10-1D were predicted through </a:t>
            </a:r>
            <a:r>
              <a:rPr lang="en-US" altLang="ko-KR" sz="10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seTTAFold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Red circles indicate the MYB domains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DB9BCB61-588C-4A78-AD16-D3D0A20E6762}"/>
              </a:ext>
            </a:extLst>
          </p:cNvPr>
          <p:cNvGrpSpPr/>
          <p:nvPr/>
        </p:nvGrpSpPr>
        <p:grpSpPr>
          <a:xfrm>
            <a:off x="4206957" y="1439329"/>
            <a:ext cx="1805501" cy="997595"/>
            <a:chOff x="4206957" y="1738545"/>
            <a:chExt cx="1805501" cy="997595"/>
          </a:xfrm>
        </p:grpSpPr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956F1109-EBB1-451D-9E8A-9747ED1ACEFC}"/>
                </a:ext>
              </a:extLst>
            </p:cNvPr>
            <p:cNvGrpSpPr/>
            <p:nvPr/>
          </p:nvGrpSpPr>
          <p:grpSpPr>
            <a:xfrm>
              <a:off x="4206957" y="1872140"/>
              <a:ext cx="1805501" cy="864000"/>
              <a:chOff x="4206957" y="1872140"/>
              <a:chExt cx="1805501" cy="864000"/>
            </a:xfrm>
          </p:grpSpPr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09058E06-ED56-4997-955A-5F8699808A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06957" y="1872140"/>
                <a:ext cx="1805501" cy="864000"/>
              </a:xfrm>
              <a:prstGeom prst="rect">
                <a:avLst/>
              </a:prstGeom>
            </p:spPr>
          </p:pic>
          <p:sp>
            <p:nvSpPr>
              <p:cNvPr id="21" name="타원 20">
                <a:extLst>
                  <a:ext uri="{FF2B5EF4-FFF2-40B4-BE49-F238E27FC236}">
                    <a16:creationId xmlns:a16="http://schemas.microsoft.com/office/drawing/2014/main" id="{2A865A3D-424B-463C-9732-F50F81290D6A}"/>
                  </a:ext>
                </a:extLst>
              </p:cNvPr>
              <p:cNvSpPr/>
              <p:nvPr/>
            </p:nvSpPr>
            <p:spPr>
              <a:xfrm rot="2821150">
                <a:off x="5300651" y="2006634"/>
                <a:ext cx="477688" cy="847835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52B92755-2AE8-4EE5-A84A-F6E031791E5D}"/>
                </a:ext>
              </a:extLst>
            </p:cNvPr>
            <p:cNvSpPr/>
            <p:nvPr/>
          </p:nvSpPr>
          <p:spPr>
            <a:xfrm>
              <a:off x="4928404" y="1738545"/>
              <a:ext cx="6880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YB10-1D</a:t>
              </a:r>
              <a:endParaRPr lang="ko-KR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72327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35</TotalTime>
  <Words>29</Words>
  <Application>Microsoft Office PowerPoint</Application>
  <PresentationFormat>사용자 지정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e Yoon Kim</dc:creator>
  <cp:lastModifiedBy>이만보</cp:lastModifiedBy>
  <cp:revision>285</cp:revision>
  <dcterms:created xsi:type="dcterms:W3CDTF">2012-09-21T02:05:55Z</dcterms:created>
  <dcterms:modified xsi:type="dcterms:W3CDTF">2025-08-31T06:22:35Z</dcterms:modified>
</cp:coreProperties>
</file>